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2021"/>
    <p:restoredTop sz="96327"/>
  </p:normalViewPr>
  <p:slideViewPr>
    <p:cSldViewPr snapToGrid="0" snapToObjects="1">
      <p:cViewPr varScale="1">
        <p:scale>
          <a:sx n="78" d="100"/>
          <a:sy n="78" d="100"/>
        </p:scale>
        <p:origin x="199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8D85B-0829-6442-AA41-2EEDC795B34A}" type="datetimeFigureOut">
              <a:rPr lang="en-US" smtClean="0"/>
              <a:t>2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2D5D2-1C4C-564E-B4BB-3F04CEE19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865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8D85B-0829-6442-AA41-2EEDC795B34A}" type="datetimeFigureOut">
              <a:rPr lang="en-US" smtClean="0"/>
              <a:t>2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2D5D2-1C4C-564E-B4BB-3F04CEE19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7320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8D85B-0829-6442-AA41-2EEDC795B34A}" type="datetimeFigureOut">
              <a:rPr lang="en-US" smtClean="0"/>
              <a:t>2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2D5D2-1C4C-564E-B4BB-3F04CEE19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4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8D85B-0829-6442-AA41-2EEDC795B34A}" type="datetimeFigureOut">
              <a:rPr lang="en-US" smtClean="0"/>
              <a:t>2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2D5D2-1C4C-564E-B4BB-3F04CEE19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199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8D85B-0829-6442-AA41-2EEDC795B34A}" type="datetimeFigureOut">
              <a:rPr lang="en-US" smtClean="0"/>
              <a:t>2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2D5D2-1C4C-564E-B4BB-3F04CEE19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042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8D85B-0829-6442-AA41-2EEDC795B34A}" type="datetimeFigureOut">
              <a:rPr lang="en-US" smtClean="0"/>
              <a:t>2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2D5D2-1C4C-564E-B4BB-3F04CEE19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511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8D85B-0829-6442-AA41-2EEDC795B34A}" type="datetimeFigureOut">
              <a:rPr lang="en-US" smtClean="0"/>
              <a:t>2/15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2D5D2-1C4C-564E-B4BB-3F04CEE19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665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8D85B-0829-6442-AA41-2EEDC795B34A}" type="datetimeFigureOut">
              <a:rPr lang="en-US" smtClean="0"/>
              <a:t>2/15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2D5D2-1C4C-564E-B4BB-3F04CEE19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91405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8D85B-0829-6442-AA41-2EEDC795B34A}" type="datetimeFigureOut">
              <a:rPr lang="en-US" smtClean="0"/>
              <a:t>2/15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2D5D2-1C4C-564E-B4BB-3F04CEE19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312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8D85B-0829-6442-AA41-2EEDC795B34A}" type="datetimeFigureOut">
              <a:rPr lang="en-US" smtClean="0"/>
              <a:t>2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2D5D2-1C4C-564E-B4BB-3F04CEE19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9878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68D85B-0829-6442-AA41-2EEDC795B34A}" type="datetimeFigureOut">
              <a:rPr lang="en-US" smtClean="0"/>
              <a:t>2/1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2D5D2-1C4C-564E-B4BB-3F04CEE19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5769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8D85B-0829-6442-AA41-2EEDC795B34A}" type="datetimeFigureOut">
              <a:rPr lang="en-US" smtClean="0"/>
              <a:t>2/1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2D5D2-1C4C-564E-B4BB-3F04CEE193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94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0DD4A6B0-91BE-AA47-AA69-41817C98348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3047081"/>
              </p:ext>
            </p:extLst>
          </p:nvPr>
        </p:nvGraphicFramePr>
        <p:xfrm>
          <a:off x="947272" y="1542709"/>
          <a:ext cx="5602158" cy="5107293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721239">
                  <a:extLst>
                    <a:ext uri="{9D8B030D-6E8A-4147-A177-3AD203B41FA5}">
                      <a16:colId xmlns:a16="http://schemas.microsoft.com/office/drawing/2014/main" val="2676657058"/>
                    </a:ext>
                  </a:extLst>
                </a:gridCol>
                <a:gridCol w="2555575">
                  <a:extLst>
                    <a:ext uri="{9D8B030D-6E8A-4147-A177-3AD203B41FA5}">
                      <a16:colId xmlns:a16="http://schemas.microsoft.com/office/drawing/2014/main" val="3410893414"/>
                    </a:ext>
                  </a:extLst>
                </a:gridCol>
                <a:gridCol w="2325344">
                  <a:extLst>
                    <a:ext uri="{9D8B030D-6E8A-4147-A177-3AD203B41FA5}">
                      <a16:colId xmlns:a16="http://schemas.microsoft.com/office/drawing/2014/main" val="784355691"/>
                    </a:ext>
                  </a:extLst>
                </a:gridCol>
              </a:tblGrid>
              <a:tr h="13394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Primer (5’-3’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Primer (5’-3’)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57056896"/>
                  </a:ext>
                </a:extLst>
              </a:tr>
              <a:tr h="13394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c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marL="0" marR="0" indent="0" algn="l" defTabSz="7772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CACAAAGACCGACAGAT 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marL="0" marR="0" indent="0" algn="l" defTabSz="7772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CTCTGTGAAGGTGAGCA </a:t>
                      </a: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3219355540"/>
                  </a:ext>
                </a:extLst>
              </a:tr>
              <a:tr h="13394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t1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marL="0" marR="0" indent="0" algn="l" defTabSz="7772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CAAGCTCTTCTGGGTGC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marL="0" marR="0" indent="0" algn="l" defTabSz="7772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CTCAGCACAGTTGCCCAT</a:t>
                      </a: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99929340"/>
                  </a:ext>
                </a:extLst>
              </a:tr>
              <a:tr h="10111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d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TGCCCGAGACGGAT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CATCCATGGTCACCCCA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2644098558"/>
                  </a:ext>
                </a:extLst>
              </a:tr>
              <a:tr h="10111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dh1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GCGCTGCTCATTACCG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CGAATGTGGAGATACCCG</a:t>
                      </a: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2113002399"/>
                  </a:ext>
                </a:extLst>
              </a:tr>
              <a:tr h="10111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t1b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CACTGCACCTAGCTCAA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TGGTTGTGTCATCCTCCA</a:t>
                      </a: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3343266386"/>
                  </a:ext>
                </a:extLst>
              </a:tr>
              <a:tr h="10111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pt2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GAACGCCTATCCTCTGG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CCCTGTCCAGGTGTCTC</a:t>
                      </a: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2414219391"/>
                  </a:ext>
                </a:extLst>
              </a:tr>
              <a:tr h="10111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s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GGCATGCTTCTAAAGCCG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CGTACGACAGCTCCTGTG</a:t>
                      </a: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3260395088"/>
                  </a:ext>
                </a:extLst>
              </a:tr>
              <a:tr h="15909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bp1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GCCATCGTTGTAGAGC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TTTTTCTGACGGCTCGC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ctr"/>
                </a:tc>
                <a:extLst>
                  <a:ext uri="{0D108BD9-81ED-4DB2-BD59-A6C34878D82A}">
                    <a16:rowId xmlns:a16="http://schemas.microsoft.com/office/drawing/2014/main" val="3021755030"/>
                  </a:ext>
                </a:extLst>
              </a:tr>
              <a:tr h="81145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6pd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ATGATGGGCAGTCGAG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CTGAGCGAGCAAAACC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21421071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k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TGGGTGTAGAGCCGTC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AGACGACGCACTGTTTT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ctr"/>
                </a:tc>
                <a:extLst>
                  <a:ext uri="{0D108BD9-81ED-4DB2-BD59-A6C34878D82A}">
                    <a16:rowId xmlns:a16="http://schemas.microsoft.com/office/drawing/2014/main" val="15262037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mgcl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CACCAAGCAAAGTGGCAG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GACGAGTCCACGACACTC</a:t>
                      </a:r>
                    </a:p>
                  </a:txBody>
                  <a:tcPr marL="6279" marR="6279" marT="6279" marB="0" anchor="ctr"/>
                </a:tc>
                <a:extLst>
                  <a:ext uri="{0D108BD9-81ED-4DB2-BD59-A6C34878D82A}">
                    <a16:rowId xmlns:a16="http://schemas.microsoft.com/office/drawing/2014/main" val="2053745925"/>
                  </a:ext>
                </a:extLst>
              </a:tr>
              <a:tr h="10679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mgcs1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CTCCGAATCTAACCGTCCG</a:t>
                      </a:r>
                    </a:p>
                  </a:txBody>
                  <a:tcPr marL="6279" marR="6279" marT="6279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GTCCCAGACCAACAGTG</a:t>
                      </a:r>
                    </a:p>
                  </a:txBody>
                  <a:tcPr marL="6279" marR="6279" marT="6279" marB="0" anchor="ctr"/>
                </a:tc>
                <a:extLst>
                  <a:ext uri="{0D108BD9-81ED-4DB2-BD59-A6C34878D82A}">
                    <a16:rowId xmlns:a16="http://schemas.microsoft.com/office/drawing/2014/main" val="17240508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dh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AATGGTTGGAATGGCTG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TCTGGACAAGGTTCAGG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2381245268"/>
                  </a:ext>
                </a:extLst>
              </a:tr>
              <a:tr h="4975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or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AACTTGCCCAGGTGAGT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CAGCACCTCCAGTAGAG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4276052897"/>
                  </a:ext>
                </a:extLst>
              </a:tr>
              <a:tr h="8301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hz1.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GAGTGTGGTCAGAAG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GAGGATTCATTGGGTGGA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4236494929"/>
                  </a:ext>
                </a:extLst>
              </a:tr>
              <a:tr h="75102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rk2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TATTGGAATAGGGGGTGTGAC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TGTCTAAAGCCGTCCTCCC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1401706106"/>
                  </a:ext>
                </a:extLst>
              </a:tr>
              <a:tr h="7539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s2b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ACCGAATCACTGCTCTGT</a:t>
                      </a:r>
                      <a:endParaRPr lang="en-US" sz="12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CTTTAAGATGCCAGCCAC</a:t>
                      </a:r>
                      <a:endParaRPr lang="en-US" sz="1200" b="0" i="0" u="none" strike="noStrike">
                        <a:solidFill>
                          <a:srgbClr val="22222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3361868926"/>
                  </a:ext>
                </a:extLst>
              </a:tr>
              <a:tr h="13394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f2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TCGACTTCAGCTACCGGC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TGACATGGGATCGGCCTC</a:t>
                      </a: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32686006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f2b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GGCAAACACTCTCCAGTTT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ATATGCGCGCTGTCGTG</a:t>
                      </a: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744506373"/>
                  </a:ext>
                </a:extLst>
              </a:tr>
              <a:tr h="13811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c1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TGAGACATGACGGGGA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GTACTGGGCTTCTCGCA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940565914"/>
                  </a:ext>
                </a:extLst>
              </a:tr>
              <a:tr h="42383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np5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CGGATTCGCTGGAAACAA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CTCGAATGACGGTCCTC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ctr"/>
                </a:tc>
                <a:extLst>
                  <a:ext uri="{0D108BD9-81ED-4DB2-BD59-A6C34878D82A}">
                    <a16:rowId xmlns:a16="http://schemas.microsoft.com/office/drawing/2014/main" val="411943692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ara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marL="0" marR="0" indent="0" algn="l" defTabSz="7772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CTGGACAGCTTCCTCTAA 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marL="0" marR="0" indent="0" algn="l" defTabSz="7772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ACACACGTGCTTTGGCT </a:t>
                      </a: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150980611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arab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marL="0" marR="0" indent="0" algn="l" defTabSz="7772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TGAACGCCGCTGTAAGAT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marL="0" marR="0" indent="0" algn="l" defTabSz="7772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TCTCGTTCTCCCGTCAGG</a:t>
                      </a: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27249568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arg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marL="0" marR="0" indent="0" algn="l" defTabSz="7772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CTCTCCGCTGATATGGTGG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marL="0" marR="0" indent="0" algn="l" defTabSz="7772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TAGATGGGCTCGTGTGTCC</a:t>
                      </a: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493385469"/>
                  </a:ext>
                </a:extLst>
              </a:tr>
              <a:tr h="4019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lenof</a:t>
                      </a:r>
                      <a:endParaRPr lang="en-US" sz="1200" b="0" i="1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GTTATTACAGGGGTTGGCG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GATGGCTCCTGGGTAGAG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295233956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rt3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TTCACTGGTTGGCGTGA </a:t>
                      </a:r>
                    </a:p>
                  </a:txBody>
                  <a:tcPr marL="6279" marR="6279" marT="6279" marB="0" anchor="b"/>
                </a:tc>
                <a:tc>
                  <a:txBody>
                    <a:bodyPr/>
                    <a:lstStyle/>
                    <a:p>
                      <a:pPr marL="0" marR="0" indent="0" algn="l" defTabSz="77724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TTTCGTAGAGGCGTGTGT </a:t>
                      </a:r>
                    </a:p>
                  </a:txBody>
                  <a:tcPr marL="6279" marR="6279" marT="6279" marB="0" anchor="b"/>
                </a:tc>
                <a:extLst>
                  <a:ext uri="{0D108BD9-81ED-4DB2-BD59-A6C34878D82A}">
                    <a16:rowId xmlns:a16="http://schemas.microsoft.com/office/drawing/2014/main" val="267509073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48EC6F7-7012-3746-A348-157C0F2D7B4A}"/>
              </a:ext>
            </a:extLst>
          </p:cNvPr>
          <p:cNvSpPr txBox="1"/>
          <p:nvPr/>
        </p:nvSpPr>
        <p:spPr>
          <a:xfrm>
            <a:off x="457200" y="228600"/>
            <a:ext cx="1905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Table 2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DDA2366-67E8-4349-9624-0E1BC00ABCBE}"/>
              </a:ext>
            </a:extLst>
          </p:cNvPr>
          <p:cNvSpPr txBox="1"/>
          <p:nvPr/>
        </p:nvSpPr>
        <p:spPr>
          <a:xfrm>
            <a:off x="2514600" y="1173377"/>
            <a:ext cx="2743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rimer sequences for qPCR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C06288E-066B-1845-8E75-70E38B5CF2C1}"/>
              </a:ext>
            </a:extLst>
          </p:cNvPr>
          <p:cNvSpPr txBox="1"/>
          <p:nvPr/>
        </p:nvSpPr>
        <p:spPr>
          <a:xfrm>
            <a:off x="5791200" y="80010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7766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</TotalTime>
  <Words>100</Words>
  <Application>Microsoft Macintosh PowerPoint</Application>
  <PresentationFormat>Custom</PresentationFormat>
  <Paragraphs>8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ler, Rosa Moon</dc:creator>
  <cp:lastModifiedBy>Keller, Rosa</cp:lastModifiedBy>
  <cp:revision>10</cp:revision>
  <dcterms:created xsi:type="dcterms:W3CDTF">2020-11-24T19:10:50Z</dcterms:created>
  <dcterms:modified xsi:type="dcterms:W3CDTF">2022-02-15T23:36:22Z</dcterms:modified>
</cp:coreProperties>
</file>